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20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A584FF-49A2-1DE4-5E79-08E791B28D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C0FE91-8BE3-DFCC-0BE3-B83F6D5A74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3AC11C-4DBF-92FD-EB7E-73B30563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84436B-5265-E0CC-899E-EB511628A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37E832-011F-FD52-96E4-74B32FC48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293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D2778A-934A-3364-A9E5-D61864C5C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FC2193-700D-DE30-9C11-B4084A8A37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5AAC71-9620-D0E2-9E0C-DC6803223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341C8F-9A64-3348-2100-9E4C049AC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65104C-DA64-E96F-1B99-B1787218F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591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AEC848C-1EB3-3E0B-E3FB-1A63D32F6E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B2C8E33-F456-64C5-6E43-075E431470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B410FF-9D48-A3D6-A4D0-B4B23950A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194D3F-E52F-4C2B-5A5B-D90AE1A27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4AD742-F151-B506-4154-FAF441263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19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29EAC5-7687-FE6B-B593-B107F90F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BD74A9-B803-CCC9-795D-4D049989E3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DB685E-422C-09B3-DF53-F8CF6AF20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57B6B8-2FE2-10F7-DE9F-0297758EB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49932B-7A69-17EA-AB9A-044FE98D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44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257DB7-F96A-D4E7-4E08-CAD485A40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CEBD86-933B-EB3E-EAC7-FF76008BA5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2991BE-0764-A991-2024-4AF0C36A2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047631-7E82-9BFD-C765-2CDC34811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DB025D-92D7-1677-9E05-A22B77D5F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58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B27F21-7A1D-E817-5CBB-77389933F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E42105-BF47-53FD-D5D2-3FA2EF61E3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477262-2500-B05A-54CD-F93146794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9A0C0C-DFAB-7759-ECD2-C85A7F7FC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2FC692-C592-F840-923C-0AC45DEE6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429C20-0236-E990-54EC-1E4350487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027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F6B28C-8A5A-8D2E-1856-1C0E3DA1F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D0ECA-D83E-8B14-1D2A-3D4838E6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904181C-39BC-E0D4-0EC3-ABCAFFE43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7DF30C-4A25-967F-C438-178B812D2B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C1CC019-68DB-58EE-112F-B22C495CA1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4FB3BA6-2827-2CA3-E5D0-53CC5B412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E0C6840-B9F7-F2BF-B80F-AEC7D1CD1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769955-ED16-4D6F-DD44-832832EB5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448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2D5E86-57A7-019E-1A85-686A7F536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D53B8E-283D-3F78-197D-2F07142A1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261FA00-6AB4-D18D-361F-CA77DE819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E6D804-D89E-F793-9153-9FB9FD6CA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5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6EDBBC9-776A-DDE2-E164-461D572FF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0D1A60D-A4BE-CBDF-E0A4-62F1F5B8F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63A8B32-7DA3-EA31-3963-7AE339121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334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AF4EB-8743-2FAD-4F4E-FCA6B5CAA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848083-BDA7-FE00-5085-F09FB08F29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A72FF6-CD48-8805-116C-1E8940C7F4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AB57A9-377B-0662-E241-A098B436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0ED9DC0-CAE7-9D95-EF7C-C105C5D43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492CF0-E5F0-0212-D30C-7FFC70490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033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89D402-9EA9-F660-04F9-568EB0795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8F5B5F-3BC5-E3D4-DE10-9711EDC99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68E0CC-A824-554D-1794-28FFF1B51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597B69-9A13-8196-F6CC-D35AA582D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05AD4A-B3B5-12BD-9CFA-6228B32AD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8759DE-70DD-7E6A-5057-414DA4F7D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D8F6A26-D969-5505-3FE8-1DA7299B7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5AB325-D862-DFD2-BD38-B3949095E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949120-A90A-6835-042E-3CC9BF59BC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8FC23A-CBE5-8B97-02F2-75BC206810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64CB32-FF74-C1CB-441C-C7639A1F37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37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図 135">
            <a:extLst>
              <a:ext uri="{FF2B5EF4-FFF2-40B4-BE49-F238E27FC236}">
                <a16:creationId xmlns:a16="http://schemas.microsoft.com/office/drawing/2014/main" id="{0FC9DF46-633E-8788-292C-09A08DC3CD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997" y="293815"/>
            <a:ext cx="8716037" cy="6333178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4699A58-B6C1-B294-3DC7-A70E0D589E61}"/>
              </a:ext>
            </a:extLst>
          </p:cNvPr>
          <p:cNvSpPr/>
          <p:nvPr/>
        </p:nvSpPr>
        <p:spPr>
          <a:xfrm>
            <a:off x="708489" y="349231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F77728E-1E43-DAE7-32F5-2BD22C36E2DA}"/>
              </a:ext>
            </a:extLst>
          </p:cNvPr>
          <p:cNvSpPr/>
          <p:nvPr/>
        </p:nvSpPr>
        <p:spPr>
          <a:xfrm>
            <a:off x="708489" y="2265114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04B5964-726A-D1AF-E829-B75319FF49F4}"/>
              </a:ext>
            </a:extLst>
          </p:cNvPr>
          <p:cNvSpPr/>
          <p:nvPr/>
        </p:nvSpPr>
        <p:spPr>
          <a:xfrm>
            <a:off x="708489" y="4289465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E44D0396-A123-6880-A1BB-77201E3754EB}"/>
              </a:ext>
            </a:extLst>
          </p:cNvPr>
          <p:cNvCxnSpPr>
            <a:cxnSpLocks/>
          </p:cNvCxnSpPr>
          <p:nvPr/>
        </p:nvCxnSpPr>
        <p:spPr>
          <a:xfrm>
            <a:off x="345593" y="2324848"/>
            <a:ext cx="86853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98EBC9C-474B-4214-3362-2EEAF94175CE}"/>
              </a:ext>
            </a:extLst>
          </p:cNvPr>
          <p:cNvCxnSpPr>
            <a:cxnSpLocks/>
          </p:cNvCxnSpPr>
          <p:nvPr/>
        </p:nvCxnSpPr>
        <p:spPr>
          <a:xfrm>
            <a:off x="345593" y="4244528"/>
            <a:ext cx="8685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C08831-8FF2-FD5A-6054-CE1B4258FB76}"/>
              </a:ext>
            </a:extLst>
          </p:cNvPr>
          <p:cNvSpPr txBox="1"/>
          <p:nvPr/>
        </p:nvSpPr>
        <p:spPr>
          <a:xfrm>
            <a:off x="363044" y="456726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Health check-up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8673211-331C-F142-ACE0-ED11649CFAB4}"/>
              </a:ext>
            </a:extLst>
          </p:cNvPr>
          <p:cNvSpPr txBox="1"/>
          <p:nvPr/>
        </p:nvSpPr>
        <p:spPr>
          <a:xfrm>
            <a:off x="363044" y="2400049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ervical cancer screening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4F036A-BBE7-902B-32AD-D82B0056DAB3}"/>
              </a:ext>
            </a:extLst>
          </p:cNvPr>
          <p:cNvSpPr txBox="1"/>
          <p:nvPr/>
        </p:nvSpPr>
        <p:spPr>
          <a:xfrm>
            <a:off x="363044" y="4279163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reast cancer screening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602E51-7DE8-C1ED-5FC9-2A7D72BE339A}"/>
              </a:ext>
            </a:extLst>
          </p:cNvPr>
          <p:cNvSpPr txBox="1"/>
          <p:nvPr/>
        </p:nvSpPr>
        <p:spPr>
          <a:xfrm>
            <a:off x="3427198" y="6395028"/>
            <a:ext cx="6149196" cy="308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revalence ratio (wives undergoing wellness examinations) with 95% confidence intervals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816B24F-650F-F14B-D282-03C5B67D78BD}"/>
              </a:ext>
            </a:extLst>
          </p:cNvPr>
          <p:cNvSpPr txBox="1"/>
          <p:nvPr/>
        </p:nvSpPr>
        <p:spPr>
          <a:xfrm rot="10800000">
            <a:off x="-22825" y="887880"/>
            <a:ext cx="428322" cy="48655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ype of wellness examination by medical insurance type of wife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924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3</TotalTime>
  <Words>85</Words>
  <Application>Microsoft Office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邊 多永子</dc:creator>
  <cp:lastModifiedBy>多永子 渡邊</cp:lastModifiedBy>
  <cp:revision>25</cp:revision>
  <dcterms:created xsi:type="dcterms:W3CDTF">2023-06-28T12:05:12Z</dcterms:created>
  <dcterms:modified xsi:type="dcterms:W3CDTF">2024-03-21T09:22:11Z</dcterms:modified>
</cp:coreProperties>
</file>